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7" r:id="rId4"/>
    <p:sldId id="258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78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0042" autoAdjust="0"/>
    <p:restoredTop sz="94660"/>
  </p:normalViewPr>
  <p:slideViewPr>
    <p:cSldViewPr snapToGrid="0">
      <p:cViewPr varScale="1">
        <p:scale>
          <a:sx n="79" d="100"/>
          <a:sy n="79" d="100"/>
        </p:scale>
        <p:origin x="8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4-Feb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5000" dirty="0">
                <a:latin typeface="+mn-lt"/>
                <a:cs typeface="Calibri"/>
              </a:rPr>
              <a:t>Representative combined spectra</a:t>
            </a:r>
            <a:br>
              <a:rPr lang="en-US" dirty="0"/>
            </a:b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BFE2975-8430-4267-931A-1F7B66907A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69074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A4FE9BD-F5DB-04CC-CFF9-5BC0AE96D499}"/>
              </a:ext>
            </a:extLst>
          </p:cNvPr>
          <p:cNvSpPr txBox="1"/>
          <p:nvPr/>
        </p:nvSpPr>
        <p:spPr>
          <a:xfrm>
            <a:off x="9537289" y="816077"/>
            <a:ext cx="1318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</a:t>
            </a:r>
          </a:p>
          <a:p>
            <a:r>
              <a:rPr lang="en-US" sz="1200" dirty="0"/>
              <a:t>challenged 48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C10CEC-A272-EF9C-11D7-AA79DBEE3FC9}"/>
              </a:ext>
            </a:extLst>
          </p:cNvPr>
          <p:cNvSpPr txBox="1"/>
          <p:nvPr/>
        </p:nvSpPr>
        <p:spPr>
          <a:xfrm>
            <a:off x="11367450" y="447727"/>
            <a:ext cx="313167" cy="368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986626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F27C802-5E5C-458B-BBCC-603B10F9F3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751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4A0D09C-5EF6-A1CB-C720-EA1C990730ED}"/>
              </a:ext>
            </a:extLst>
          </p:cNvPr>
          <p:cNvSpPr txBox="1"/>
          <p:nvPr/>
        </p:nvSpPr>
        <p:spPr>
          <a:xfrm>
            <a:off x="9537289" y="816077"/>
            <a:ext cx="125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</a:t>
            </a:r>
          </a:p>
          <a:p>
            <a:r>
              <a:rPr lang="en-US" sz="1200" dirty="0"/>
              <a:t>challenged 7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DA98B9-0B70-4713-E177-B59AE72F55B8}"/>
              </a:ext>
            </a:extLst>
          </p:cNvPr>
          <p:cNvSpPr txBox="1"/>
          <p:nvPr/>
        </p:nvSpPr>
        <p:spPr>
          <a:xfrm>
            <a:off x="11333403" y="446745"/>
            <a:ext cx="313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J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9075486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D94E2B-EEA8-44F1-B58E-E1D0A8F164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47"/>
            <a:ext cx="12192000" cy="6626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863846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A23A070-A147-49BB-A7BD-88EE23E828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202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6825F1-71CE-B1B8-81A6-ACF170FC3842}"/>
              </a:ext>
            </a:extLst>
          </p:cNvPr>
          <p:cNvSpPr txBox="1"/>
          <p:nvPr/>
        </p:nvSpPr>
        <p:spPr>
          <a:xfrm>
            <a:off x="9537289" y="816077"/>
            <a:ext cx="11047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non-challenged 6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DAEE5E1-7048-5A99-C511-0A6AA3C8D7CB}"/>
              </a:ext>
            </a:extLst>
          </p:cNvPr>
          <p:cNvSpPr txBox="1"/>
          <p:nvPr/>
        </p:nvSpPr>
        <p:spPr>
          <a:xfrm>
            <a:off x="11474141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K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523633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589E066-EFC5-46E3-AFC8-1FCF9023C8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6264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DB6B4F0-D7F9-1B2E-391C-C24BABDD98A9}"/>
              </a:ext>
            </a:extLst>
          </p:cNvPr>
          <p:cNvSpPr txBox="1"/>
          <p:nvPr/>
        </p:nvSpPr>
        <p:spPr>
          <a:xfrm>
            <a:off x="9537289" y="816077"/>
            <a:ext cx="11825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non-challenged 12 h</a:t>
            </a:r>
            <a:endParaRPr lang="pt-PT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10611D5-13BA-5AAF-3C85-475F27392A6B}"/>
              </a:ext>
            </a:extLst>
          </p:cNvPr>
          <p:cNvSpPr txBox="1"/>
          <p:nvPr/>
        </p:nvSpPr>
        <p:spPr>
          <a:xfrm>
            <a:off x="11435230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160851978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738E599-9721-459A-9809-11FAFFBCDE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71A77D3-287D-1EA1-AE8D-F136A2331348}"/>
              </a:ext>
            </a:extLst>
          </p:cNvPr>
          <p:cNvSpPr txBox="1"/>
          <p:nvPr/>
        </p:nvSpPr>
        <p:spPr>
          <a:xfrm>
            <a:off x="9537289" y="816077"/>
            <a:ext cx="11631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non-challenged 24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FC0740B-27ED-C0F8-02DE-91AB22DF8CBE}"/>
              </a:ext>
            </a:extLst>
          </p:cNvPr>
          <p:cNvSpPr txBox="1"/>
          <p:nvPr/>
        </p:nvSpPr>
        <p:spPr>
          <a:xfrm>
            <a:off x="11282517" y="55050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1007491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6F6FD5A-803E-40CE-B763-F1D9354307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7689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643D8CD-F137-C889-AFD6-23F6B3506DDB}"/>
              </a:ext>
            </a:extLst>
          </p:cNvPr>
          <p:cNvSpPr txBox="1"/>
          <p:nvPr/>
        </p:nvSpPr>
        <p:spPr>
          <a:xfrm>
            <a:off x="9537289" y="816077"/>
            <a:ext cx="11728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non-challenged 48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FF02965-E593-275E-FA61-76A474476D8F}"/>
              </a:ext>
            </a:extLst>
          </p:cNvPr>
          <p:cNvSpPr txBox="1"/>
          <p:nvPr/>
        </p:nvSpPr>
        <p:spPr>
          <a:xfrm>
            <a:off x="11386592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39564657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0A28770-E1CE-4AB5-95A7-9077EE5436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6023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B296D59-DF7F-9B67-3471-C871F4ED9235}"/>
              </a:ext>
            </a:extLst>
          </p:cNvPr>
          <p:cNvSpPr txBox="1"/>
          <p:nvPr/>
        </p:nvSpPr>
        <p:spPr>
          <a:xfrm>
            <a:off x="9537289" y="816077"/>
            <a:ext cx="12020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non-challenged 7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7BA3740-6EF7-1FF8-4A8A-CBB1F77D27FF}"/>
              </a:ext>
            </a:extLst>
          </p:cNvPr>
          <p:cNvSpPr txBox="1"/>
          <p:nvPr/>
        </p:nvSpPr>
        <p:spPr>
          <a:xfrm>
            <a:off x="11415775" y="540773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17428277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A77E428-E4CC-402A-B0C8-B8D12B04E8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46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39BDAF-F285-81AB-2225-44F771F2F0C4}"/>
              </a:ext>
            </a:extLst>
          </p:cNvPr>
          <p:cNvSpPr txBox="1"/>
          <p:nvPr/>
        </p:nvSpPr>
        <p:spPr>
          <a:xfrm>
            <a:off x="9537289" y="816077"/>
            <a:ext cx="11047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challenged 6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5B96CE-45DE-31EB-6237-037F63CA9AB5}"/>
              </a:ext>
            </a:extLst>
          </p:cNvPr>
          <p:cNvSpPr txBox="1"/>
          <p:nvPr/>
        </p:nvSpPr>
        <p:spPr>
          <a:xfrm>
            <a:off x="11396320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16741085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9F4985C-8D81-49F6-8A39-C64FD0D1C3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751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4BBB80-0313-1621-81F7-637E04B42FBB}"/>
              </a:ext>
            </a:extLst>
          </p:cNvPr>
          <p:cNvSpPr txBox="1"/>
          <p:nvPr/>
        </p:nvSpPr>
        <p:spPr>
          <a:xfrm>
            <a:off x="9537289" y="816077"/>
            <a:ext cx="1231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challenged 1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CAC5916-CD2C-F1E5-DAB2-3F70B1FA4ECD}"/>
              </a:ext>
            </a:extLst>
          </p:cNvPr>
          <p:cNvSpPr txBox="1"/>
          <p:nvPr/>
        </p:nvSpPr>
        <p:spPr>
          <a:xfrm>
            <a:off x="11406048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Q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243698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35FE171-C027-4493-9776-00B452F941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651" y="543768"/>
            <a:ext cx="12192000" cy="662649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C59ADFE-CCD0-A832-2132-E1FF0CB20ED2}"/>
              </a:ext>
            </a:extLst>
          </p:cNvPr>
          <p:cNvSpPr txBox="1"/>
          <p:nvPr/>
        </p:nvSpPr>
        <p:spPr>
          <a:xfrm>
            <a:off x="9537289" y="816077"/>
            <a:ext cx="11012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 non-challenged 6 h</a:t>
            </a:r>
            <a:endParaRPr lang="pt-PT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FF11C1-218A-BA9D-745E-BD95539CD2B6}"/>
              </a:ext>
            </a:extLst>
          </p:cNvPr>
          <p:cNvSpPr txBox="1"/>
          <p:nvPr/>
        </p:nvSpPr>
        <p:spPr>
          <a:xfrm>
            <a:off x="11408347" y="543768"/>
            <a:ext cx="383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82967323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01A4236-AF0C-4F41-821F-851778DED6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47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903AB65-913C-A6AF-809F-DB111F07BB6B}"/>
              </a:ext>
            </a:extLst>
          </p:cNvPr>
          <p:cNvSpPr txBox="1"/>
          <p:nvPr/>
        </p:nvSpPr>
        <p:spPr>
          <a:xfrm>
            <a:off x="9537289" y="816077"/>
            <a:ext cx="1231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challenged 24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342B26F-A70F-2481-35D3-A1D894EB930C}"/>
              </a:ext>
            </a:extLst>
          </p:cNvPr>
          <p:cNvSpPr txBox="1"/>
          <p:nvPr/>
        </p:nvSpPr>
        <p:spPr>
          <a:xfrm>
            <a:off x="11406048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85819058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AB80858-2917-4D34-8FD2-1AC8F11F8B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47"/>
            <a:ext cx="12192000" cy="662649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E9D8353-761B-50A5-25D1-7E4203D0E297}"/>
              </a:ext>
            </a:extLst>
          </p:cNvPr>
          <p:cNvSpPr txBox="1"/>
          <p:nvPr/>
        </p:nvSpPr>
        <p:spPr>
          <a:xfrm>
            <a:off x="9537289" y="816077"/>
            <a:ext cx="1231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challenged 48 h</a:t>
            </a:r>
            <a:endParaRPr lang="pt-PT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5331B2C-554E-B1D8-1761-FB1EA80BDA8E}"/>
              </a:ext>
            </a:extLst>
          </p:cNvPr>
          <p:cNvSpPr txBox="1"/>
          <p:nvPr/>
        </p:nvSpPr>
        <p:spPr>
          <a:xfrm>
            <a:off x="11444959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61689408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25043ED-69EF-4F59-BB8E-B038058D8C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187" y="0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666216B-F26A-3180-B530-0115DA5AE708}"/>
              </a:ext>
            </a:extLst>
          </p:cNvPr>
          <p:cNvSpPr txBox="1"/>
          <p:nvPr/>
        </p:nvSpPr>
        <p:spPr>
          <a:xfrm>
            <a:off x="9537289" y="816077"/>
            <a:ext cx="1231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oots challenged 7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066D7F3-15FA-AF63-BF6D-E3411755F140}"/>
              </a:ext>
            </a:extLst>
          </p:cNvPr>
          <p:cNvSpPr txBox="1"/>
          <p:nvPr/>
        </p:nvSpPr>
        <p:spPr>
          <a:xfrm>
            <a:off x="11406048" y="443751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96265028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295846A-B7BC-4885-8D33-0B9FC2BC4F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751"/>
            <a:ext cx="12192000" cy="6626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5615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7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AC8F09-9994-4F74-B262-635D8C0411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0183" y="351726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A834A65-8AF7-938C-8F1A-C2A636B443E6}"/>
              </a:ext>
            </a:extLst>
          </p:cNvPr>
          <p:cNvSpPr txBox="1"/>
          <p:nvPr/>
        </p:nvSpPr>
        <p:spPr>
          <a:xfrm>
            <a:off x="9537289" y="816077"/>
            <a:ext cx="1211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 non-challenged 12 h</a:t>
            </a:r>
            <a:endParaRPr lang="pt-PT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170B995-8006-B734-FFA6-3843364C495D}"/>
              </a:ext>
            </a:extLst>
          </p:cNvPr>
          <p:cNvSpPr txBox="1"/>
          <p:nvPr/>
        </p:nvSpPr>
        <p:spPr>
          <a:xfrm>
            <a:off x="11464413" y="540774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960306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5A2C519-0B37-42BF-BA58-05E8403200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475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5F35B44-C5C3-7E89-D0E3-BF3B7FF4ACDD}"/>
              </a:ext>
            </a:extLst>
          </p:cNvPr>
          <p:cNvSpPr txBox="1"/>
          <p:nvPr/>
        </p:nvSpPr>
        <p:spPr>
          <a:xfrm>
            <a:off x="9537289" y="816077"/>
            <a:ext cx="118259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 non-challenged 24 h</a:t>
            </a:r>
            <a:endParaRPr lang="pt-PT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5AF84CB-EBD5-E346-1FE5-EACF456162FC}"/>
              </a:ext>
            </a:extLst>
          </p:cNvPr>
          <p:cNvSpPr txBox="1"/>
          <p:nvPr/>
        </p:nvSpPr>
        <p:spPr>
          <a:xfrm>
            <a:off x="11464413" y="540774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41294036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E0E8EE8-8419-4F34-BCFA-090FF6023C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94" y="115751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F592254-28D2-8A39-6D93-FC848E72D3FF}"/>
              </a:ext>
            </a:extLst>
          </p:cNvPr>
          <p:cNvSpPr txBox="1"/>
          <p:nvPr/>
        </p:nvSpPr>
        <p:spPr>
          <a:xfrm>
            <a:off x="9537289" y="816077"/>
            <a:ext cx="125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 non-challenged 48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5D2FA1-D08C-E785-7236-24DEBDFCA71E}"/>
              </a:ext>
            </a:extLst>
          </p:cNvPr>
          <p:cNvSpPr txBox="1"/>
          <p:nvPr/>
        </p:nvSpPr>
        <p:spPr>
          <a:xfrm>
            <a:off x="11464413" y="540774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6125813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6091163-4BD6-48A3-A1E3-22A871894D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1502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8FB0961-50B7-11D5-7895-A6F5F3B2F97B}"/>
              </a:ext>
            </a:extLst>
          </p:cNvPr>
          <p:cNvSpPr txBox="1"/>
          <p:nvPr/>
        </p:nvSpPr>
        <p:spPr>
          <a:xfrm>
            <a:off x="9537289" y="816077"/>
            <a:ext cx="12117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 non-challenged 7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8F6BCB1-6F7C-B384-9D1B-95B0CE8DAE98}"/>
              </a:ext>
            </a:extLst>
          </p:cNvPr>
          <p:cNvSpPr txBox="1"/>
          <p:nvPr/>
        </p:nvSpPr>
        <p:spPr>
          <a:xfrm>
            <a:off x="11415775" y="540773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11188341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8D19933-2237-4207-9EAA-BE9B852B1D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474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28A7F12-1DF4-51FA-7C62-1676E8C6BD59}"/>
              </a:ext>
            </a:extLst>
          </p:cNvPr>
          <p:cNvSpPr txBox="1"/>
          <p:nvPr/>
        </p:nvSpPr>
        <p:spPr>
          <a:xfrm>
            <a:off x="9537289" y="825805"/>
            <a:ext cx="11534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</a:t>
            </a:r>
          </a:p>
          <a:p>
            <a:r>
              <a:rPr lang="en-US" sz="1200" dirty="0"/>
              <a:t>challenged 6 h</a:t>
            </a:r>
            <a:endParaRPr lang="pt-PT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4D1988-E404-CF6D-E243-203DD6D37B5B}"/>
              </a:ext>
            </a:extLst>
          </p:cNvPr>
          <p:cNvSpPr txBox="1"/>
          <p:nvPr/>
        </p:nvSpPr>
        <p:spPr>
          <a:xfrm>
            <a:off x="11415775" y="540773"/>
            <a:ext cx="327392" cy="372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9050433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D077A6A-2DA7-43C6-B21C-92EA17929F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7549" y="368670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F763D27-E511-8BF4-A6BD-79EAB5323848}"/>
              </a:ext>
            </a:extLst>
          </p:cNvPr>
          <p:cNvSpPr txBox="1"/>
          <p:nvPr/>
        </p:nvSpPr>
        <p:spPr>
          <a:xfrm>
            <a:off x="9537289" y="816077"/>
            <a:ext cx="12604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</a:t>
            </a:r>
          </a:p>
          <a:p>
            <a:r>
              <a:rPr lang="en-US" sz="1200" dirty="0"/>
              <a:t>challenged 12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AF074D2-8735-F478-DBF5-D15E2A68306A}"/>
              </a:ext>
            </a:extLst>
          </p:cNvPr>
          <p:cNvSpPr txBox="1"/>
          <p:nvPr/>
        </p:nvSpPr>
        <p:spPr>
          <a:xfrm>
            <a:off x="11294493" y="446745"/>
            <a:ext cx="254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7706513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F79732-8B9B-4E3B-8995-F70B7C13DE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751"/>
            <a:ext cx="12192000" cy="6626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3F17FAC-EDC7-E942-9C5A-E61F70A9F262}"/>
              </a:ext>
            </a:extLst>
          </p:cNvPr>
          <p:cNvSpPr txBox="1"/>
          <p:nvPr/>
        </p:nvSpPr>
        <p:spPr>
          <a:xfrm>
            <a:off x="9537289" y="816077"/>
            <a:ext cx="12798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aves</a:t>
            </a:r>
          </a:p>
          <a:p>
            <a:r>
              <a:rPr lang="en-US" sz="1200" dirty="0"/>
              <a:t>challenged 24 h</a:t>
            </a:r>
            <a:endParaRPr lang="pt-PT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07D6B5-8146-4244-EED2-2CB1B0737F68}"/>
              </a:ext>
            </a:extLst>
          </p:cNvPr>
          <p:cNvSpPr txBox="1"/>
          <p:nvPr/>
        </p:nvSpPr>
        <p:spPr>
          <a:xfrm>
            <a:off x="11459182" y="282103"/>
            <a:ext cx="313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003107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104</Words>
  <Application>Microsoft Office PowerPoint</Application>
  <PresentationFormat>Widescreen</PresentationFormat>
  <Paragraphs>46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office theme</vt:lpstr>
      <vt:lpstr>Representative combined spectra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ravad</dc:creator>
  <cp:lastModifiedBy>Alfredo Jaime Morais Cravador</cp:lastModifiedBy>
  <cp:revision>44</cp:revision>
  <dcterms:created xsi:type="dcterms:W3CDTF">2021-11-30T15:53:20Z</dcterms:created>
  <dcterms:modified xsi:type="dcterms:W3CDTF">2023-02-14T21:36:39Z</dcterms:modified>
</cp:coreProperties>
</file>